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80" userDrawn="1">
          <p15:clr>
            <a:srgbClr val="A4A3A4"/>
          </p15:clr>
        </p15:guide>
        <p15:guide id="2" pos="13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09" autoAdjust="0"/>
    <p:restoredTop sz="94660"/>
  </p:normalViewPr>
  <p:slideViewPr>
    <p:cSldViewPr snapToGrid="0">
      <p:cViewPr>
        <p:scale>
          <a:sx n="50" d="100"/>
          <a:sy n="50" d="100"/>
        </p:scale>
        <p:origin x="1834" y="602"/>
      </p:cViewPr>
      <p:guideLst>
        <p:guide orient="horz" pos="3680"/>
        <p:guide pos="13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C9102CD-1FCA-6386-CB76-BEF1A4D19E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05C17A8-68CC-5786-7C3C-6234E882E5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84C2201-E89F-E52B-DAFE-497779594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F70AAA-234C-EB03-09B8-ADC4606D3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35CAAF-059D-647B-3337-0DAF06FC9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0222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2B58F5-E28C-E87E-9C2D-E02BCAABEB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A308E8F-AD44-7268-938B-23D8594AB8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4905A64-C685-D75C-2D84-E91E19C3E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A5FBF20-B02B-43AF-59BE-F01E6FE0C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2CB1FB5-FA26-E495-2FC8-C51C07FAC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9666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51D0DE7-A619-A962-DE7A-4DFAFD25E0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D8B5DDA-FED2-C304-814F-02C4989343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6BBA401-0664-1CFE-FD7A-160DD5EC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97B8781-D38A-0DE2-E63F-8AD51C926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FD3FECB-1B1B-906E-D56F-A1A48C49C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1664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4243C6B-0503-BB3F-A038-21495C2FA6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AA866F9-02A4-30C3-B802-2C98C90A7E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ADB419-FCC0-4871-E94E-49A1DC6D1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7B0C709-395B-4863-2EBE-50EFDE8EF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088743-B026-E07E-5107-C90F9F302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3999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E780C91-7AA5-75F3-C66C-358473B15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E6F1FBC-40D6-73FF-6C3B-30866A652B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D3E99BB-670D-395A-AC4C-E0F3F2512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B708FFB-20BA-50B0-47AF-AC52D7F08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54F343-55F3-A156-4E84-05AF3A2F7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778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7D4A05A-74A2-CA4C-D7FE-FA248B3D1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DE3311B-99F0-DB56-11EA-7E9CD8656D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4437AB4-B850-64A6-2DBC-BDA27F708A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5BA82B5-BB93-B5BD-C56F-DDCAAA17E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B241D1F-D37F-C439-61AD-F0863983F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36AFBDD-FD02-BD5C-77A2-34D02AEF8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0328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99C92C-CEA5-E47C-7F97-DDD45E89A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63FB96C-1DBE-F5A2-8924-C18A181370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518D96F-EDBE-413C-8280-93930D3E2D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FD635AB-C368-BD3D-F8DC-7E2BDF4F80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91C30EC-5087-8B37-DD31-603CF9CFFA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33F6018-7E1D-D563-787D-05E9729E4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B51298C-7476-4042-B354-36054C9BE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08C7A94-C75F-C02A-D953-964920BE0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7175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86FB4AF-09A3-C039-D332-B1F6ED3FF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FDDFA58-249E-B763-E540-B6A94B8FD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87E2A64-B3DD-C5E5-460F-D6381019C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5CE0CC7-5C36-97DA-C461-F1E130033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795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208F2CC-1072-4E9F-DFF5-D6EAA7D63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3AA2F65-1F27-226B-DC95-A56494534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C000EF3-F4C1-612B-8207-2F4419638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7953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AA61C29-B2D2-D43F-A38C-AAB1FE8E5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AFCC275-E63E-1151-5B0F-03B8C9E0D2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C2FA42A-9841-CBAA-1D0C-04A39D224D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F374D68-9076-0FBD-ABF6-C810FFBDA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56BE423-A550-6CAF-9584-951FD4D71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8AE4D1B-E0C9-DD6F-EC3D-0F54290B3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2608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5EADFB-52DB-B3C7-0407-D6D7AC5769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3D20A9B-2226-6843-07B2-FFD4CD4A29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9F81143-078C-86B2-DD37-144310D71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8211E57-E032-747B-7787-BDF62FF66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A20ADC0-BFD8-8164-6819-849049CDC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1FFBE5A-CCAC-B01A-5077-68707F2E0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66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707CBDD-ADB5-A091-5927-03AF0B70F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84DBEC7-7AC9-B42F-8FE7-05D68FDEF6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F822616-4BD0-94F1-A8A4-8BC7B97055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D771A-8D75-41D3-8E27-AD3AFB245AAA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B64AA07-C31C-A5C2-5827-CAF4A09DA1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3D8712-C8F5-FCDE-FC47-D172D23BF4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D4249-B9FC-46F7-89BC-C4C949DEC2D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8660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B176671-125D-18CC-7EED-993F0A02FC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8004" y="2506455"/>
            <a:ext cx="4384922" cy="340180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7EE42BA-1B2D-6119-7B4D-B5455EA88B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5688" y="2555681"/>
            <a:ext cx="4384923" cy="340180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E9A445FA-E09E-D2C1-A93D-0BAEE68CA031}"/>
              </a:ext>
            </a:extLst>
          </p:cNvPr>
          <p:cNvSpPr/>
          <p:nvPr/>
        </p:nvSpPr>
        <p:spPr>
          <a:xfrm>
            <a:off x="3486688" y="2831823"/>
            <a:ext cx="956653" cy="6419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85A1EE2-0D92-37E1-F74B-9C4B45D43E13}"/>
              </a:ext>
            </a:extLst>
          </p:cNvPr>
          <p:cNvSpPr/>
          <p:nvPr/>
        </p:nvSpPr>
        <p:spPr>
          <a:xfrm>
            <a:off x="7223300" y="2904030"/>
            <a:ext cx="454928" cy="5238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CasellaDiTesto 13">
            <a:extLst>
              <a:ext uri="{FF2B5EF4-FFF2-40B4-BE49-F238E27FC236}">
                <a16:creationId xmlns:a16="http://schemas.microsoft.com/office/drawing/2014/main" id="{B2806385-5738-09E8-9382-97093DDDE341}"/>
              </a:ext>
            </a:extLst>
          </p:cNvPr>
          <p:cNvSpPr txBox="1"/>
          <p:nvPr/>
        </p:nvSpPr>
        <p:spPr>
          <a:xfrm rot="16200000">
            <a:off x="2362398" y="1975073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11" name="CasellaDiTesto 16">
            <a:extLst>
              <a:ext uri="{FF2B5EF4-FFF2-40B4-BE49-F238E27FC236}">
                <a16:creationId xmlns:a16="http://schemas.microsoft.com/office/drawing/2014/main" id="{26C08D35-E9BD-55F8-EC40-FD2B47706A22}"/>
              </a:ext>
            </a:extLst>
          </p:cNvPr>
          <p:cNvSpPr txBox="1"/>
          <p:nvPr/>
        </p:nvSpPr>
        <p:spPr>
          <a:xfrm rot="16200000">
            <a:off x="3018158" y="1600879"/>
            <a:ext cx="16273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SU-RSH3</a:t>
            </a:r>
            <a:r>
              <a:rPr lang="it-IT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65-EN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8">
            <a:extLst>
              <a:ext uri="{FF2B5EF4-FFF2-40B4-BE49-F238E27FC236}">
                <a16:creationId xmlns:a16="http://schemas.microsoft.com/office/drawing/2014/main" id="{2227EA05-CC5F-0D08-5AEC-76E7574D6BA1}"/>
              </a:ext>
            </a:extLst>
          </p:cNvPr>
          <p:cNvSpPr txBox="1"/>
          <p:nvPr/>
        </p:nvSpPr>
        <p:spPr>
          <a:xfrm rot="16200000">
            <a:off x="3499915" y="1574429"/>
            <a:ext cx="168026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SU-RSH3*</a:t>
            </a:r>
            <a:r>
              <a:rPr lang="it-IT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95-EN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3">
            <a:extLst>
              <a:ext uri="{FF2B5EF4-FFF2-40B4-BE49-F238E27FC236}">
                <a16:creationId xmlns:a16="http://schemas.microsoft.com/office/drawing/2014/main" id="{75F66938-4419-F65C-4745-F13BFFA3EFC0}"/>
              </a:ext>
            </a:extLst>
          </p:cNvPr>
          <p:cNvSpPr txBox="1"/>
          <p:nvPr/>
        </p:nvSpPr>
        <p:spPr>
          <a:xfrm rot="16200000">
            <a:off x="6948949" y="2049400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14" name="CasellaDiTesto 16">
            <a:extLst>
              <a:ext uri="{FF2B5EF4-FFF2-40B4-BE49-F238E27FC236}">
                <a16:creationId xmlns:a16="http://schemas.microsoft.com/office/drawing/2014/main" id="{940E5B34-C6FB-F6E7-DC49-752E61B24F53}"/>
              </a:ext>
            </a:extLst>
          </p:cNvPr>
          <p:cNvSpPr txBox="1"/>
          <p:nvPr/>
        </p:nvSpPr>
        <p:spPr>
          <a:xfrm rot="16200000">
            <a:off x="7655254" y="1551654"/>
            <a:ext cx="16273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SU-RSH3</a:t>
            </a:r>
            <a:r>
              <a:rPr lang="it-IT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65-EN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8">
            <a:extLst>
              <a:ext uri="{FF2B5EF4-FFF2-40B4-BE49-F238E27FC236}">
                <a16:creationId xmlns:a16="http://schemas.microsoft.com/office/drawing/2014/main" id="{335641F4-5720-2F2B-C320-55C4135C10E2}"/>
              </a:ext>
            </a:extLst>
          </p:cNvPr>
          <p:cNvSpPr txBox="1"/>
          <p:nvPr/>
        </p:nvSpPr>
        <p:spPr>
          <a:xfrm rot="16200000">
            <a:off x="8137011" y="1525204"/>
            <a:ext cx="168026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SU-RSH3*</a:t>
            </a:r>
            <a:r>
              <a:rPr lang="it-IT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195-EN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7">
            <a:extLst>
              <a:ext uri="{FF2B5EF4-FFF2-40B4-BE49-F238E27FC236}">
                <a16:creationId xmlns:a16="http://schemas.microsoft.com/office/drawing/2014/main" id="{A0B180E6-0C02-4ADB-BF9F-23062AC73F27}"/>
              </a:ext>
            </a:extLst>
          </p:cNvPr>
          <p:cNvSpPr txBox="1"/>
          <p:nvPr/>
        </p:nvSpPr>
        <p:spPr>
          <a:xfrm>
            <a:off x="328670" y="410852"/>
            <a:ext cx="1027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</a:p>
        </p:txBody>
      </p:sp>
    </p:spTree>
    <p:extLst>
      <p:ext uri="{BB962C8B-B14F-4D97-AF65-F5344CB8AC3E}">
        <p14:creationId xmlns:p14="http://schemas.microsoft.com/office/powerpoint/2010/main" val="1097935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1E18FA1E-F073-A994-B2EA-38200CFE24F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65" t="32036" r="15054" b="31488"/>
          <a:stretch/>
        </p:blipFill>
        <p:spPr bwMode="auto">
          <a:xfrm>
            <a:off x="2063750" y="2417609"/>
            <a:ext cx="5230136" cy="34243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asellaDiTesto 13">
            <a:extLst>
              <a:ext uri="{FF2B5EF4-FFF2-40B4-BE49-F238E27FC236}">
                <a16:creationId xmlns:a16="http://schemas.microsoft.com/office/drawing/2014/main" id="{CF10BB90-9A7B-BB19-92BB-BA25C09FE61D}"/>
              </a:ext>
            </a:extLst>
          </p:cNvPr>
          <p:cNvSpPr txBox="1"/>
          <p:nvPr/>
        </p:nvSpPr>
        <p:spPr>
          <a:xfrm rot="16200000">
            <a:off x="2331141" y="1792119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4" name="CasellaDiTesto 16">
            <a:extLst>
              <a:ext uri="{FF2B5EF4-FFF2-40B4-BE49-F238E27FC236}">
                <a16:creationId xmlns:a16="http://schemas.microsoft.com/office/drawing/2014/main" id="{77D60DB1-986E-0848-E192-97BAC739AA54}"/>
              </a:ext>
            </a:extLst>
          </p:cNvPr>
          <p:cNvSpPr txBox="1"/>
          <p:nvPr/>
        </p:nvSpPr>
        <p:spPr>
          <a:xfrm rot="16200000">
            <a:off x="3152137" y="1394990"/>
            <a:ext cx="16946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RSH3</a:t>
            </a:r>
            <a:r>
              <a:rPr lang="it-I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5-EN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18">
            <a:extLst>
              <a:ext uri="{FF2B5EF4-FFF2-40B4-BE49-F238E27FC236}">
                <a16:creationId xmlns:a16="http://schemas.microsoft.com/office/drawing/2014/main" id="{A385E947-4D65-C388-AB6A-2A0B46FB9EF7}"/>
              </a:ext>
            </a:extLst>
          </p:cNvPr>
          <p:cNvSpPr txBox="1"/>
          <p:nvPr/>
        </p:nvSpPr>
        <p:spPr>
          <a:xfrm rot="16200000">
            <a:off x="3601834" y="1368540"/>
            <a:ext cx="18117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RSH3*</a:t>
            </a:r>
            <a:r>
              <a:rPr lang="it-I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95-EN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34E6A62-F649-AFD8-62BA-16528A79675E}"/>
              </a:ext>
            </a:extLst>
          </p:cNvPr>
          <p:cNvSpPr/>
          <p:nvPr/>
        </p:nvSpPr>
        <p:spPr>
          <a:xfrm>
            <a:off x="3688080" y="3547661"/>
            <a:ext cx="1050444" cy="6419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FDEDC68-32C2-83F3-C2CF-807915831EDF}"/>
              </a:ext>
            </a:extLst>
          </p:cNvPr>
          <p:cNvSpPr/>
          <p:nvPr/>
        </p:nvSpPr>
        <p:spPr>
          <a:xfrm>
            <a:off x="2567939" y="3572272"/>
            <a:ext cx="630985" cy="6419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E9B5C30-A72C-0111-0F3C-C978D3D4FCB6}"/>
              </a:ext>
            </a:extLst>
          </p:cNvPr>
          <p:cNvSpPr txBox="1"/>
          <p:nvPr/>
        </p:nvSpPr>
        <p:spPr>
          <a:xfrm>
            <a:off x="328670" y="416516"/>
            <a:ext cx="1027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</a:p>
        </p:txBody>
      </p:sp>
    </p:spTree>
    <p:extLst>
      <p:ext uri="{BB962C8B-B14F-4D97-AF65-F5344CB8AC3E}">
        <p14:creationId xmlns:p14="http://schemas.microsoft.com/office/powerpoint/2010/main" val="22636787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Office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D'Alessandro</dc:creator>
  <cp:lastModifiedBy>FIELD Benjamin</cp:lastModifiedBy>
  <cp:revision>3</cp:revision>
  <dcterms:created xsi:type="dcterms:W3CDTF">2022-07-18T11:05:18Z</dcterms:created>
  <dcterms:modified xsi:type="dcterms:W3CDTF">2023-04-13T20:16:49Z</dcterms:modified>
</cp:coreProperties>
</file>